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86" d="100"/>
          <a:sy n="86" d="100"/>
        </p:scale>
        <p:origin x="-1824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omfs01.ad.fiu.edu\academic_affairs$\IUAGOULNIKLab\MYLES\qPCR\PC-3%20Tet-On\COX2%20INPP4B%20for%20pape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comfs01.ad.fiu.edu\academic_affairs$\IUAGOULNIKLab\MYLES\qPCR\PC-3%20Tet-On\COX2%20INPP4B%20for%20pape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comfs01.ad.fiu.edu\academic_affairs$\IUAGOULNIKLab\MYLES\PROTEIN\Densitometry\COX2%201-12-1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comfs01.ad.fiu.edu\academic_affairs$\IUAGOULNIKLab\MYLES\PROTEIN\Densitometry\LNCaP%20KD%202-8-13%20Densitomet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7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8:$F$9</c:f>
                <c:numCache>
                  <c:formatCode>General</c:formatCode>
                  <c:ptCount val="2"/>
                  <c:pt idx="0">
                    <c:v>0.12791211657122301</c:v>
                  </c:pt>
                  <c:pt idx="1">
                    <c:v>7.2542539190366795E-2</c:v>
                  </c:pt>
                </c:numCache>
              </c:numRef>
            </c:plus>
            <c:minus>
              <c:numRef>
                <c:f>Sheet1!$F$8:$F$9</c:f>
                <c:numCache>
                  <c:formatCode>General</c:formatCode>
                  <c:ptCount val="2"/>
                  <c:pt idx="0">
                    <c:v>0.12791211657122301</c:v>
                  </c:pt>
                  <c:pt idx="1">
                    <c:v>7.2542539190366795E-2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Sheet1!$B$8:$B$9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C$8:$C$9</c:f>
              <c:numCache>
                <c:formatCode>0.000</c:formatCode>
                <c:ptCount val="2"/>
                <c:pt idx="0">
                  <c:v>1.043390403308478</c:v>
                </c:pt>
                <c:pt idx="1">
                  <c:v>1.040171803547848</c:v>
                </c:pt>
              </c:numCache>
            </c:numRef>
          </c:val>
        </c:ser>
        <c:ser>
          <c:idx val="1"/>
          <c:order val="1"/>
          <c:tx>
            <c:strRef>
              <c:f>Sheet1!$D$7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8:$G$9</c:f>
                <c:numCache>
                  <c:formatCode>General</c:formatCode>
                  <c:ptCount val="2"/>
                  <c:pt idx="0">
                    <c:v>6.03112082456514E-2</c:v>
                  </c:pt>
                  <c:pt idx="1">
                    <c:v>3.8079081173025422</c:v>
                  </c:pt>
                </c:numCache>
              </c:numRef>
            </c:plus>
            <c:minus>
              <c:numRef>
                <c:f>Sheet1!$G$8:$G$9</c:f>
                <c:numCache>
                  <c:formatCode>General</c:formatCode>
                  <c:ptCount val="2"/>
                  <c:pt idx="0">
                    <c:v>6.03112082456514E-2</c:v>
                  </c:pt>
                  <c:pt idx="1">
                    <c:v>3.8079081173025422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Sheet1!$B$8:$B$9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D$8:$D$9</c:f>
              <c:numCache>
                <c:formatCode>0.000</c:formatCode>
                <c:ptCount val="2"/>
                <c:pt idx="0">
                  <c:v>1.1153897431833151</c:v>
                </c:pt>
                <c:pt idx="1">
                  <c:v>42.4881295746964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2307840"/>
        <c:axId val="52309376"/>
      </c:barChart>
      <c:catAx>
        <c:axId val="523078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52309376"/>
        <c:crosses val="autoZero"/>
        <c:auto val="1"/>
        <c:lblAlgn val="ctr"/>
        <c:lblOffset val="100"/>
        <c:noMultiLvlLbl val="0"/>
      </c:catAx>
      <c:valAx>
        <c:axId val="5230937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52307840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70625546806649198"/>
          <c:y val="0.36784371860924803"/>
          <c:w val="0.182633420822397"/>
          <c:h val="0.3054648261559900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2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3:$F$4</c:f>
                <c:numCache>
                  <c:formatCode>General</c:formatCode>
                  <c:ptCount val="2"/>
                  <c:pt idx="0">
                    <c:v>0.12941675419642801</c:v>
                  </c:pt>
                  <c:pt idx="1">
                    <c:v>0.13242914993573399</c:v>
                  </c:pt>
                </c:numCache>
              </c:numRef>
            </c:plus>
            <c:minus>
              <c:numRef>
                <c:f>Sheet1!$F$3:$F$4</c:f>
                <c:numCache>
                  <c:formatCode>General</c:formatCode>
                  <c:ptCount val="2"/>
                  <c:pt idx="0">
                    <c:v>0.12941675419642801</c:v>
                  </c:pt>
                  <c:pt idx="1">
                    <c:v>0.13242914993573399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Sheet1!$B$3:$B$4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C$3:$C$4</c:f>
              <c:numCache>
                <c:formatCode>0.000</c:formatCode>
                <c:ptCount val="2"/>
                <c:pt idx="0">
                  <c:v>1.041440770938872</c:v>
                </c:pt>
                <c:pt idx="1">
                  <c:v>1.0375818144591149</c:v>
                </c:pt>
              </c:numCache>
            </c:numRef>
          </c:val>
        </c:ser>
        <c:ser>
          <c:idx val="1"/>
          <c:order val="1"/>
          <c:tx>
            <c:strRef>
              <c:f>Sheet1!$D$2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3:$G$4</c:f>
                <c:numCache>
                  <c:formatCode>General</c:formatCode>
                  <c:ptCount val="2"/>
                  <c:pt idx="0">
                    <c:v>3.2134680235605999E-2</c:v>
                  </c:pt>
                  <c:pt idx="1">
                    <c:v>3.8604779090091801E-2</c:v>
                  </c:pt>
                </c:numCache>
              </c:numRef>
            </c:plus>
            <c:minus>
              <c:numRef>
                <c:f>Sheet1!$G$3:$G$4</c:f>
                <c:numCache>
                  <c:formatCode>General</c:formatCode>
                  <c:ptCount val="2"/>
                  <c:pt idx="0">
                    <c:v>3.2134680235605999E-2</c:v>
                  </c:pt>
                  <c:pt idx="1">
                    <c:v>3.8604779090091801E-2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Sheet1!$B$3:$B$4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D$3:$D$4</c:f>
              <c:numCache>
                <c:formatCode>0.000</c:formatCode>
                <c:ptCount val="2"/>
                <c:pt idx="0">
                  <c:v>0.79319367414955</c:v>
                </c:pt>
                <c:pt idx="1">
                  <c:v>0.371970424527676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2323456"/>
        <c:axId val="52324992"/>
      </c:barChart>
      <c:catAx>
        <c:axId val="523234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52324992"/>
        <c:crosses val="autoZero"/>
        <c:auto val="1"/>
        <c:lblAlgn val="ctr"/>
        <c:lblOffset val="100"/>
        <c:noMultiLvlLbl val="0"/>
      </c:catAx>
      <c:valAx>
        <c:axId val="52324992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523234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0625546806649198"/>
          <c:y val="0.36784371860924803"/>
          <c:w val="0.182633420822397"/>
          <c:h val="0.3054648261559900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15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 w="25400">
              <a:solidFill>
                <a:schemeClr val="tx1"/>
              </a:solidFill>
            </a:ln>
          </c:spPr>
          <c:invertIfNegative val="0"/>
          <c:cat>
            <c:strRef>
              <c:f>Sheet1!$B$16:$B$17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C$16:$C$17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D$15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cat>
            <c:strRef>
              <c:f>Sheet1!$B$16:$B$17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D$16:$D$17</c:f>
              <c:numCache>
                <c:formatCode>General</c:formatCode>
                <c:ptCount val="2"/>
                <c:pt idx="0">
                  <c:v>1.0348422357714031</c:v>
                </c:pt>
                <c:pt idx="1">
                  <c:v>0.3622677687398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2337664"/>
        <c:axId val="52339456"/>
      </c:barChart>
      <c:catAx>
        <c:axId val="523376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52339456"/>
        <c:crosses val="autoZero"/>
        <c:auto val="1"/>
        <c:lblAlgn val="ctr"/>
        <c:lblOffset val="100"/>
        <c:noMultiLvlLbl val="0"/>
      </c:catAx>
      <c:valAx>
        <c:axId val="523394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52337664"/>
        <c:crosses val="autoZero"/>
        <c:crossBetween val="between"/>
        <c:majorUnit val="0.4"/>
      </c:valAx>
    </c:plotArea>
    <c:legend>
      <c:legendPos val="r"/>
      <c:layout>
        <c:manualLayout>
          <c:xMode val="edge"/>
          <c:yMode val="edge"/>
          <c:x val="0.69390978905414602"/>
          <c:y val="0.36784371860924803"/>
          <c:w val="0.182633420822397"/>
          <c:h val="0.3054648261559900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cat>
            <c:strRef>
              <c:f>Sheet1!$Q$2:$Q$4</c:f>
              <c:strCache>
                <c:ptCount val="3"/>
                <c:pt idx="0">
                  <c:v>C</c:v>
                </c:pt>
                <c:pt idx="1">
                  <c:v>INPP-1</c:v>
                </c:pt>
                <c:pt idx="2">
                  <c:v>INPP-2</c:v>
                </c:pt>
              </c:strCache>
            </c:strRef>
          </c:cat>
          <c:val>
            <c:numRef>
              <c:f>Sheet1!$O$2:$O$4</c:f>
              <c:numCache>
                <c:formatCode>General</c:formatCode>
                <c:ptCount val="3"/>
                <c:pt idx="0">
                  <c:v>1</c:v>
                </c:pt>
                <c:pt idx="1">
                  <c:v>3.369837969400105</c:v>
                </c:pt>
                <c:pt idx="2">
                  <c:v>5.15871672759937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460800"/>
        <c:axId val="54462336"/>
      </c:barChart>
      <c:catAx>
        <c:axId val="544608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54462336"/>
        <c:crosses val="autoZero"/>
        <c:auto val="1"/>
        <c:lblAlgn val="ctr"/>
        <c:lblOffset val="100"/>
        <c:noMultiLvlLbl val="0"/>
      </c:catAx>
      <c:valAx>
        <c:axId val="54462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544608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764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162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828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120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051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665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58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033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359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933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838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996C9-647E-4CB5-A66D-5C3ACFA344C9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17E1BF-5FFD-4716-82B4-B54A3FCF3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43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openxmlformats.org/officeDocument/2006/relationships/chart" Target="../charts/chart2.xml"/><Relationship Id="rId7" Type="http://schemas.openxmlformats.org/officeDocument/2006/relationships/image" Target="../media/image3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tiff"/><Relationship Id="rId11" Type="http://schemas.openxmlformats.org/officeDocument/2006/relationships/image" Target="../media/image6.tiff"/><Relationship Id="rId5" Type="http://schemas.openxmlformats.org/officeDocument/2006/relationships/image" Target="../media/image1.tiff"/><Relationship Id="rId10" Type="http://schemas.openxmlformats.org/officeDocument/2006/relationships/image" Target="../media/image5.tiff"/><Relationship Id="rId4" Type="http://schemas.openxmlformats.org/officeDocument/2006/relationships/chart" Target="../charts/chart3.xml"/><Relationship Id="rId9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762000" y="838200"/>
          <a:ext cx="2057400" cy="1234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2714625" y="838200"/>
          <a:ext cx="2057400" cy="1234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857625" y="1438275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*</a:t>
            </a:r>
            <a:endParaRPr lang="en-US" sz="8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872720" y="99032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***</a:t>
            </a:r>
            <a:endParaRPr lang="en-US" sz="800" b="1" dirty="0"/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/>
          </p:nvPr>
        </p:nvGraphicFramePr>
        <p:xfrm>
          <a:off x="2714625" y="2324100"/>
          <a:ext cx="2057400" cy="1234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399594" y="1261870"/>
            <a:ext cx="7585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smtClean="0"/>
              <a:t>INPP4B/18s</a:t>
            </a:r>
            <a:endParaRPr lang="en-US" sz="800" b="1" i="1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2376682" y="1290724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smtClean="0"/>
              <a:t>COX-2/18s</a:t>
            </a:r>
            <a:endParaRPr lang="en-US" sz="800" b="1" i="1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74" t="55920" r="41363" b="28712"/>
          <a:stretch/>
        </p:blipFill>
        <p:spPr>
          <a:xfrm>
            <a:off x="972312" y="3165729"/>
            <a:ext cx="1097100" cy="30546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55" t="26949" r="41523" b="56830"/>
          <a:stretch/>
        </p:blipFill>
        <p:spPr>
          <a:xfrm>
            <a:off x="972312" y="2516505"/>
            <a:ext cx="1097100" cy="32119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1" name="TextBox 10"/>
          <p:cNvSpPr txBox="1"/>
          <p:nvPr/>
        </p:nvSpPr>
        <p:spPr>
          <a:xfrm>
            <a:off x="2023261" y="2863452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COX-2</a:t>
            </a:r>
            <a:endParaRPr lang="en-US" sz="8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023261" y="2585806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FLAG</a:t>
            </a:r>
            <a:endParaRPr lang="en-US" sz="8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023261" y="3190875"/>
            <a:ext cx="5549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Tubulin</a:t>
            </a:r>
            <a:endParaRPr lang="en-US" sz="800" b="1" dirty="0"/>
          </a:p>
        </p:txBody>
      </p:sp>
      <p:sp>
        <p:nvSpPr>
          <p:cNvPr id="16" name="TextBox 16"/>
          <p:cNvSpPr txBox="1">
            <a:spLocks noChangeArrowheads="1"/>
          </p:cNvSpPr>
          <p:nvPr/>
        </p:nvSpPr>
        <p:spPr bwMode="auto">
          <a:xfrm>
            <a:off x="478599" y="609600"/>
            <a:ext cx="29368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A</a:t>
            </a:r>
          </a:p>
        </p:txBody>
      </p:sp>
      <p:sp>
        <p:nvSpPr>
          <p:cNvPr id="17" name="TextBox 51"/>
          <p:cNvSpPr txBox="1">
            <a:spLocks noChangeArrowheads="1"/>
          </p:cNvSpPr>
          <p:nvPr/>
        </p:nvSpPr>
        <p:spPr bwMode="auto">
          <a:xfrm>
            <a:off x="658938" y="2295502"/>
            <a:ext cx="14302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 err="1">
                <a:cs typeface="Arial" charset="0"/>
              </a:rPr>
              <a:t>Dox</a:t>
            </a:r>
            <a:r>
              <a:rPr lang="en-US" sz="800" b="1" dirty="0">
                <a:cs typeface="Arial" charset="0"/>
              </a:rPr>
              <a:t>     -    </a:t>
            </a:r>
            <a:r>
              <a:rPr lang="en-US" sz="800" b="1" dirty="0" smtClean="0">
                <a:cs typeface="Arial" charset="0"/>
              </a:rPr>
              <a:t>    </a:t>
            </a:r>
            <a:r>
              <a:rPr lang="en-US" sz="800" b="1" dirty="0">
                <a:cs typeface="Arial" charset="0"/>
              </a:rPr>
              <a:t>+   </a:t>
            </a:r>
            <a:r>
              <a:rPr lang="en-US" sz="800" b="1" dirty="0" smtClean="0">
                <a:cs typeface="Arial" charset="0"/>
              </a:rPr>
              <a:t>     </a:t>
            </a:r>
            <a:r>
              <a:rPr lang="en-US" sz="800" b="1" dirty="0">
                <a:cs typeface="Arial" charset="0"/>
              </a:rPr>
              <a:t>-    </a:t>
            </a:r>
            <a:r>
              <a:rPr lang="en-US" sz="800" b="1" dirty="0" smtClean="0">
                <a:cs typeface="Arial" charset="0"/>
              </a:rPr>
              <a:t>    </a:t>
            </a:r>
            <a:r>
              <a:rPr lang="en-US" sz="800" b="1" dirty="0">
                <a:cs typeface="Arial" charset="0"/>
              </a:rPr>
              <a:t>+ </a:t>
            </a:r>
          </a:p>
        </p:txBody>
      </p:sp>
      <p:sp>
        <p:nvSpPr>
          <p:cNvPr id="19" name="TextBox 53"/>
          <p:cNvSpPr txBox="1">
            <a:spLocks noChangeArrowheads="1"/>
          </p:cNvSpPr>
          <p:nvPr/>
        </p:nvSpPr>
        <p:spPr bwMode="auto">
          <a:xfrm>
            <a:off x="1613885" y="2133577"/>
            <a:ext cx="35779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#14</a:t>
            </a:r>
            <a:endParaRPr lang="en-US" sz="800" b="1" dirty="0">
              <a:cs typeface="Arial" charset="0"/>
            </a:endParaRPr>
          </a:p>
        </p:txBody>
      </p:sp>
      <p:cxnSp>
        <p:nvCxnSpPr>
          <p:cNvPr id="21" name="Straight Connector 20"/>
          <p:cNvCxnSpPr/>
          <p:nvPr/>
        </p:nvCxnSpPr>
        <p:spPr>
          <a:xfrm>
            <a:off x="1617059" y="2297090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1082800" y="2297090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57"/>
          <p:cNvSpPr txBox="1">
            <a:spLocks noChangeArrowheads="1"/>
          </p:cNvSpPr>
          <p:nvPr/>
        </p:nvSpPr>
        <p:spPr bwMode="auto">
          <a:xfrm>
            <a:off x="1078038" y="2133577"/>
            <a:ext cx="3778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 err="1">
                <a:cs typeface="Arial" charset="0"/>
              </a:rPr>
              <a:t>Neg</a:t>
            </a:r>
            <a:endParaRPr lang="en-US" sz="800" b="1" dirty="0">
              <a:cs typeface="Arial" charset="0"/>
            </a:endParaRPr>
          </a:p>
        </p:txBody>
      </p:sp>
      <p:sp>
        <p:nvSpPr>
          <p:cNvPr id="24" name="TextBox 16"/>
          <p:cNvSpPr txBox="1">
            <a:spLocks noChangeArrowheads="1"/>
          </p:cNvSpPr>
          <p:nvPr/>
        </p:nvSpPr>
        <p:spPr bwMode="auto">
          <a:xfrm>
            <a:off x="2494724" y="609600"/>
            <a:ext cx="29368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 smtClean="0">
                <a:cs typeface="Arial" charset="0"/>
              </a:rPr>
              <a:t>B</a:t>
            </a:r>
            <a:endParaRPr lang="en-US" sz="1200" b="1" dirty="0">
              <a:cs typeface="Arial" charset="0"/>
            </a:endParaRPr>
          </a:p>
        </p:txBody>
      </p:sp>
      <p:sp>
        <p:nvSpPr>
          <p:cNvPr id="25" name="TextBox 16"/>
          <p:cNvSpPr txBox="1">
            <a:spLocks noChangeArrowheads="1"/>
          </p:cNvSpPr>
          <p:nvPr/>
        </p:nvSpPr>
        <p:spPr bwMode="auto">
          <a:xfrm>
            <a:off x="478599" y="2122009"/>
            <a:ext cx="29368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 smtClean="0">
                <a:cs typeface="Arial" charset="0"/>
              </a:rPr>
              <a:t>C</a:t>
            </a:r>
            <a:endParaRPr lang="en-US" sz="1200" b="1" dirty="0">
              <a:cs typeface="Arial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81" t="34739" r="20074" b="53253"/>
          <a:stretch/>
        </p:blipFill>
        <p:spPr>
          <a:xfrm flipH="1">
            <a:off x="969842" y="3868007"/>
            <a:ext cx="1188720" cy="37653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55" t="36705" r="40701" b="46569"/>
          <a:stretch/>
        </p:blipFill>
        <p:spPr>
          <a:xfrm flipH="1">
            <a:off x="969842" y="4743207"/>
            <a:ext cx="1188720" cy="36219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0" name="TextBox 29"/>
          <p:cNvSpPr txBox="1"/>
          <p:nvPr/>
        </p:nvSpPr>
        <p:spPr>
          <a:xfrm>
            <a:off x="2124075" y="4391083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COX-2</a:t>
            </a:r>
            <a:endParaRPr lang="en-US" sz="8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2124075" y="3946197"/>
            <a:ext cx="556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INPP4B</a:t>
            </a:r>
            <a:endParaRPr lang="en-US" sz="8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2124075" y="4832806"/>
            <a:ext cx="5549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Tubulin</a:t>
            </a:r>
            <a:endParaRPr lang="en-US" sz="800" b="1" dirty="0"/>
          </a:p>
        </p:txBody>
      </p:sp>
      <p:sp>
        <p:nvSpPr>
          <p:cNvPr id="33" name="TextBox 16"/>
          <p:cNvSpPr txBox="1">
            <a:spLocks noChangeArrowheads="1"/>
          </p:cNvSpPr>
          <p:nvPr/>
        </p:nvSpPr>
        <p:spPr bwMode="auto">
          <a:xfrm>
            <a:off x="478599" y="3585750"/>
            <a:ext cx="29368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 smtClean="0">
                <a:cs typeface="Arial" charset="0"/>
              </a:rPr>
              <a:t>D</a:t>
            </a:r>
            <a:endParaRPr lang="en-US" sz="1200" b="1" dirty="0">
              <a:cs typeface="Arial" charset="0"/>
            </a:endParaRPr>
          </a:p>
        </p:txBody>
      </p:sp>
      <p:sp>
        <p:nvSpPr>
          <p:cNvPr id="34" name="TextBox 51"/>
          <p:cNvSpPr txBox="1">
            <a:spLocks noChangeArrowheads="1"/>
          </p:cNvSpPr>
          <p:nvPr/>
        </p:nvSpPr>
        <p:spPr bwMode="auto">
          <a:xfrm>
            <a:off x="991920" y="3663993"/>
            <a:ext cx="121058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   C      INPP-1 INPP-2</a:t>
            </a:r>
            <a:endParaRPr lang="en-US" sz="800" b="1" dirty="0">
              <a:cs typeface="Arial" charset="0"/>
            </a:endParaRPr>
          </a:p>
        </p:txBody>
      </p:sp>
      <p:graphicFrame>
        <p:nvGraphicFramePr>
          <p:cNvPr id="35" name="Chart 34"/>
          <p:cNvGraphicFramePr>
            <a:graphicFrameLocks/>
          </p:cNvGraphicFramePr>
          <p:nvPr>
            <p:extLst/>
          </p:nvPr>
        </p:nvGraphicFramePr>
        <p:xfrm>
          <a:off x="2815771" y="3792913"/>
          <a:ext cx="1527629" cy="1234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97" t="23124" r="39383" b="62703"/>
          <a:stretch/>
        </p:blipFill>
        <p:spPr>
          <a:xfrm>
            <a:off x="972312" y="2869247"/>
            <a:ext cx="1097280" cy="26253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29" t="45461" r="59080" b="40815"/>
          <a:stretch/>
        </p:blipFill>
        <p:spPr>
          <a:xfrm flipH="1">
            <a:off x="969842" y="4279188"/>
            <a:ext cx="1188720" cy="43889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 rot="16200000">
            <a:off x="2324025" y="2730409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Fold Change</a:t>
            </a:r>
            <a:endParaRPr lang="en-US" sz="800" b="1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2385096" y="4222440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Fold Change</a:t>
            </a:r>
            <a:endParaRPr lang="en-US" sz="800" b="1" dirty="0"/>
          </a:p>
        </p:txBody>
      </p:sp>
      <p:sp>
        <p:nvSpPr>
          <p:cNvPr id="36" name="TextBox 67"/>
          <p:cNvSpPr txBox="1">
            <a:spLocks noChangeArrowheads="1"/>
          </p:cNvSpPr>
          <p:nvPr/>
        </p:nvSpPr>
        <p:spPr bwMode="auto">
          <a:xfrm>
            <a:off x="114300" y="36242"/>
            <a:ext cx="15648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400" b="1" dirty="0" smtClean="0">
                <a:cs typeface="Arial" charset="0"/>
              </a:rPr>
              <a:t>Additional File 2</a:t>
            </a:r>
            <a:endParaRPr lang="en-US" sz="1400" b="1" dirty="0">
              <a:cs typeface="Arial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14301" y="5340840"/>
            <a:ext cx="6286499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PP4B expression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hibits expression of COX-2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 and B) PC-3 cells from Tet-On clone #14 and the negative for INPP4B clone were cultured for 2 day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0.5 </a:t>
            </a:r>
            <a:r>
              <a:rPr lang="el-GR" sz="1200" smtClean="0">
                <a:latin typeface="Calibri"/>
                <a:cs typeface="Arial" panose="020B0604020202020204" pitchFamily="34" charset="0"/>
              </a:rPr>
              <a:t>μ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g/m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ycycline in full medium. RNA was extracted and analyzed for express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INPP4B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B) by quantitative PCR and normalized to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18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Data are presented as means ± SEM. *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&lt;0.05, ***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&lt;0.0001, two-tailed Student’s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est. (C) PC-3 control and inducible clones were cultured for 2 day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0.5 µg/ml doxycycline in serum-containing media. Proteins were extracted and the expression of FLAG-INPP4B, COX-2, and tubulin was analyzed by Western blotting.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r grap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Expression of COX-2 (fold-change) was quantified by densitometry relative to tubulin and normalized to no doxycycline for each clone (expressed as 1.0). (D) LNCaP cells were transfected with either noncoding control (Ctrl) or 2 independent INPP4B-specific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INPP-1 or INPP-2). Cells were grown for 48 hours in complete medium and cellular protein extracts were analyzed by Western blotting for INPP4B, COX-2 and tubulin.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r grap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COX-2 protein levels were quantified by densitometry, normalized to tubulin, and fold change in expression levels was determined relative to control siRNA transfected cells (1.0). Data in panels C and D were obtained three times and representative experiment shown.</a:t>
            </a:r>
          </a:p>
        </p:txBody>
      </p:sp>
    </p:spTree>
    <p:extLst>
      <p:ext uri="{BB962C8B-B14F-4D97-AF65-F5344CB8AC3E}">
        <p14:creationId xmlns:p14="http://schemas.microsoft.com/office/powerpoint/2010/main" val="3570717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85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lorida Internationa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yles Hodgson</dc:creator>
  <cp:lastModifiedBy>Irina Agoulnik</cp:lastModifiedBy>
  <cp:revision>3</cp:revision>
  <dcterms:created xsi:type="dcterms:W3CDTF">2014-03-31T17:21:57Z</dcterms:created>
  <dcterms:modified xsi:type="dcterms:W3CDTF">2014-07-29T18:59:52Z</dcterms:modified>
</cp:coreProperties>
</file>